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78120C8F-D487-44AE-8B50-2FB65D04B114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F2A05201-C571-4B2C-A498-76D78FDD789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2E3882-E8A4-4C2C-8444-EB5424F951E9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8C4FFA-26BC-4A04-B952-9CFD77E6031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718202-3D8C-409B-B7E4-17F42C6F21D7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003F4A-08A0-41A3-8741-535DED697AD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96154-A703-4F21-9622-4C07ECEF5832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86C3F4-B3F6-45DD-AFAA-BA48583390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B1B686-AEFE-47CF-855B-7FDF26A25732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5DA8C9-BCCA-4D07-9E7C-C4EEF0F237B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8E186A-F4E6-4C45-A8C3-BC1DB4C519B3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2668B0-29E1-4CBC-9440-7D1B6E46013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7CBBDE-86BA-4D8E-9D90-3CE5F3A8E758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99E32D-1557-43A6-829F-86FEFB8FA46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3BE367-C312-4199-8A19-5A3C12B2D5BF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C87E4C-5C5D-4538-9C1A-25709B23754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DAE541-94DC-4C2A-A15B-B904977B2099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48B93D-C177-4925-A12E-B4B8D4FC581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58A711-433E-4114-8385-258C2669E3BE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6BDE8B-75C5-4D0E-B69F-CCE658ECE1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140DCF-B1C3-49B1-8FF7-2EA28FBEBEC6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D2D7CE-6441-4E6B-9562-701B13C2172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7559FF-BECB-4736-B02A-621AA8D0CF57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C9B10-6FD5-40F3-A682-3BB8CFD22E3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0E518ED0-5242-47E1-BEC5-FAA7A1625B4F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7322B765-95C2-43FA-B8BE-80207F0B0FF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2286000" y="1066800"/>
          <a:ext cx="4543425" cy="4792672"/>
        </p:xfrm>
        <a:graphic>
          <a:graphicData uri="http://schemas.openxmlformats.org/drawingml/2006/table">
            <a:tbl>
              <a:tblPr/>
              <a:tblGrid>
                <a:gridCol w="892175"/>
                <a:gridCol w="1230313"/>
                <a:gridCol w="1387475"/>
                <a:gridCol w="1033462"/>
              </a:tblGrid>
              <a:tr h="4540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nimal No.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ge (weeks)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rostate lobe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athology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487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9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81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1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81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1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829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11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828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11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035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22.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8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22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8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22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8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22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7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39.6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7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39.6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 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39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41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40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41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4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41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629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5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35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56.6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78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59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70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60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63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, 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24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6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63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VP, 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S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63106" marR="63106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6</Words>
  <Application>Microsoft Office PowerPoint</Application>
  <PresentationFormat>On-screen Show (4:3)</PresentationFormat>
  <Paragraphs>8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elty</dc:creator>
  <cp:lastModifiedBy>Helty</cp:lastModifiedBy>
  <cp:revision>5</cp:revision>
  <dcterms:created xsi:type="dcterms:W3CDTF">2012-12-17T07:51:28Z</dcterms:created>
  <dcterms:modified xsi:type="dcterms:W3CDTF">2013-03-15T13:37:06Z</dcterms:modified>
</cp:coreProperties>
</file>